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47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5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-55054"/>
            <a:ext cx="10233660" cy="1136978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50000"/>
              </a:lnSpc>
            </a:pPr>
            <a:r>
              <a:rPr lang="en-SE" sz="2800" b="1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enetic </a:t>
            </a:r>
            <a:r>
              <a:rPr lang="en-US" sz="2800" b="1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</a:t>
            </a:r>
            <a:r>
              <a:rPr lang="en-SE" sz="2800" b="1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eterminants of renal </a:t>
            </a:r>
            <a:r>
              <a:rPr lang="en-SE" sz="2800" b="1" dirty="0">
                <a:solidFill>
                  <a:schemeClr val="bg1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s</a:t>
            </a:r>
            <a:r>
              <a:rPr lang="en-SE" sz="2800" b="1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arring in children</a:t>
            </a:r>
            <a:r>
              <a:rPr lang="en-US" sz="2800" b="1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</a:p>
          <a:p>
            <a:pPr>
              <a:lnSpc>
                <a:spcPct val="150000"/>
              </a:lnSpc>
            </a:pPr>
            <a:r>
              <a:rPr lang="en-SE" sz="2800" b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with </a:t>
            </a:r>
            <a:r>
              <a:rPr lang="en-SE" sz="2800" b="1" dirty="0">
                <a:solidFill>
                  <a:schemeClr val="bg1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f</a:t>
            </a:r>
            <a:r>
              <a:rPr lang="en-SE" sz="2800" b="1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ebrile UTI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A genetic susceptibility to renal scarring determines outcome after febrile UTI in infancy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Rosenblad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Children with renal scarring after febrile UTI are genetically segregated from individuals with resolved acute pyelonephritis and share a profile of polymorphic mitochondrial genes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98D320C-B162-BB8F-6940-F88B76F30A3B}"/>
              </a:ext>
            </a:extLst>
          </p:cNvPr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endParaRPr lang="en-GB" dirty="0">
              <a:solidFill>
                <a:srgbClr val="0065AA"/>
              </a:solidFill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D480672F-6F42-22E7-C16F-2D883E5C571C}"/>
              </a:ext>
            </a:extLst>
          </p:cNvPr>
          <p:cNvGrpSpPr/>
          <p:nvPr/>
        </p:nvGrpSpPr>
        <p:grpSpPr>
          <a:xfrm>
            <a:off x="4949599" y="2534915"/>
            <a:ext cx="3335838" cy="2645929"/>
            <a:chOff x="432591" y="909689"/>
            <a:chExt cx="3640946" cy="3011008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41B840BB-1373-620A-2653-4997F565F594}"/>
                </a:ext>
              </a:extLst>
            </p:cNvPr>
            <p:cNvGrpSpPr/>
            <p:nvPr/>
          </p:nvGrpSpPr>
          <p:grpSpPr>
            <a:xfrm>
              <a:off x="432591" y="909689"/>
              <a:ext cx="3640946" cy="3011008"/>
              <a:chOff x="1157338" y="1409707"/>
              <a:chExt cx="5477991" cy="4685260"/>
            </a:xfrm>
          </p:grpSpPr>
          <p:pic>
            <p:nvPicPr>
              <p:cNvPr id="8" name="Picture 7" descr="Graphical user interface, application&#10;&#10;Description automatically generated with medium confidence">
                <a:extLst>
                  <a:ext uri="{FF2B5EF4-FFF2-40B4-BE49-F238E27FC236}">
                    <a16:creationId xmlns:a16="http://schemas.microsoft.com/office/drawing/2014/main" id="{274303A1-8ADC-5F8C-ED99-16A3D7628DA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t="3138" r="31123"/>
              <a:stretch/>
            </p:blipFill>
            <p:spPr>
              <a:xfrm>
                <a:off x="2301465" y="2389459"/>
                <a:ext cx="2639518" cy="3705508"/>
              </a:xfrm>
              <a:prstGeom prst="rect">
                <a:avLst/>
              </a:prstGeom>
            </p:spPr>
          </p:pic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84A1A411-A193-F507-2AA7-C574B257EA40}"/>
                  </a:ext>
                </a:extLst>
              </p:cNvPr>
              <p:cNvGrpSpPr/>
              <p:nvPr/>
            </p:nvGrpSpPr>
            <p:grpSpPr>
              <a:xfrm>
                <a:off x="1157338" y="2302958"/>
                <a:ext cx="943328" cy="3685678"/>
                <a:chOff x="75327" y="1601988"/>
                <a:chExt cx="655078" cy="2651167"/>
              </a:xfrm>
            </p:grpSpPr>
            <p:cxnSp>
              <p:nvCxnSpPr>
                <p:cNvPr id="29" name="Straight Arrow Connector 28">
                  <a:extLst>
                    <a:ext uri="{FF2B5EF4-FFF2-40B4-BE49-F238E27FC236}">
                      <a16:creationId xmlns:a16="http://schemas.microsoft.com/office/drawing/2014/main" id="{45A6E323-5E45-C7D5-9D55-EC30EF5139E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63809" y="1664208"/>
                  <a:ext cx="0" cy="2588946"/>
                </a:xfrm>
                <a:prstGeom prst="straightConnector1">
                  <a:avLst/>
                </a:prstGeom>
                <a:ln w="38100">
                  <a:solidFill>
                    <a:schemeClr val="bg2">
                      <a:lumMod val="10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4BEBE0C8-E477-B6CB-2CAC-14E13F8A0D63}"/>
                    </a:ext>
                  </a:extLst>
                </p:cNvPr>
                <p:cNvSpPr txBox="1"/>
                <p:nvPr/>
              </p:nvSpPr>
              <p:spPr>
                <a:xfrm rot="16200000">
                  <a:off x="-194471" y="1871786"/>
                  <a:ext cx="802829" cy="26323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900" dirty="0"/>
                    <a:t>O</a:t>
                  </a:r>
                  <a:r>
                    <a:rPr lang="en-SE" sz="900" dirty="0"/>
                    <a:t>dd ratio</a:t>
                  </a:r>
                </a:p>
              </p:txBody>
            </p:sp>
            <p:sp>
              <p:nvSpPr>
                <p:cNvPr id="31" name="Rectangle 30">
                  <a:extLst>
                    <a:ext uri="{FF2B5EF4-FFF2-40B4-BE49-F238E27FC236}">
                      <a16:creationId xmlns:a16="http://schemas.microsoft.com/office/drawing/2014/main" id="{9C5FD47F-053C-7184-7FD7-7177EAF9BE8C}"/>
                    </a:ext>
                  </a:extLst>
                </p:cNvPr>
                <p:cNvSpPr/>
                <p:nvPr/>
              </p:nvSpPr>
              <p:spPr>
                <a:xfrm>
                  <a:off x="605830" y="1759445"/>
                  <a:ext cx="124575" cy="1678699"/>
                </a:xfrm>
                <a:prstGeom prst="rect">
                  <a:avLst/>
                </a:prstGeom>
                <a:solidFill>
                  <a:schemeClr val="accent2">
                    <a:lumMod val="50000"/>
                  </a:schemeClr>
                </a:solidFill>
                <a:ln>
                  <a:solidFill>
                    <a:schemeClr val="accent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E" sz="900"/>
                </a:p>
              </p:txBody>
            </p:sp>
            <p:sp>
              <p:nvSpPr>
                <p:cNvPr id="32" name="Rectangle 31">
                  <a:extLst>
                    <a:ext uri="{FF2B5EF4-FFF2-40B4-BE49-F238E27FC236}">
                      <a16:creationId xmlns:a16="http://schemas.microsoft.com/office/drawing/2014/main" id="{7BE48F3A-AA8F-0927-8540-1A97CDBE041F}"/>
                    </a:ext>
                  </a:extLst>
                </p:cNvPr>
                <p:cNvSpPr/>
                <p:nvPr/>
              </p:nvSpPr>
              <p:spPr>
                <a:xfrm>
                  <a:off x="603132" y="3487547"/>
                  <a:ext cx="124574" cy="765608"/>
                </a:xfrm>
                <a:prstGeom prst="rect">
                  <a:avLst/>
                </a:prstGeom>
                <a:solidFill>
                  <a:schemeClr val="accent2">
                    <a:lumMod val="40000"/>
                    <a:lumOff val="60000"/>
                  </a:schemeClr>
                </a:solidFill>
                <a:ln>
                  <a:solidFill>
                    <a:schemeClr val="accent2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E" sz="900"/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DC627866-B019-DF58-611C-A9DB7C26BB45}"/>
                    </a:ext>
                  </a:extLst>
                </p:cNvPr>
                <p:cNvSpPr txBox="1"/>
                <p:nvPr/>
              </p:nvSpPr>
              <p:spPr>
                <a:xfrm rot="16200000">
                  <a:off x="169066" y="2514017"/>
                  <a:ext cx="625195" cy="26323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SE" sz="900" dirty="0"/>
                    <a:t>OR &gt; 1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FFE60143-F74C-F921-DA25-79EAB88EB19F}"/>
                    </a:ext>
                  </a:extLst>
                </p:cNvPr>
                <p:cNvSpPr txBox="1"/>
                <p:nvPr/>
              </p:nvSpPr>
              <p:spPr>
                <a:xfrm rot="16200000">
                  <a:off x="87250" y="3602393"/>
                  <a:ext cx="788826" cy="2632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E" sz="900" dirty="0"/>
                    <a:t>OR &lt; 1</a:t>
                  </a:r>
                </a:p>
              </p:txBody>
            </p:sp>
          </p:grpSp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4B99BA13-4471-C9AE-0941-A5E02EEF18C7}"/>
                  </a:ext>
                </a:extLst>
              </p:cNvPr>
              <p:cNvGrpSpPr/>
              <p:nvPr/>
            </p:nvGrpSpPr>
            <p:grpSpPr>
              <a:xfrm>
                <a:off x="5247449" y="2856479"/>
                <a:ext cx="1131219" cy="1158143"/>
                <a:chOff x="5148274" y="3275958"/>
                <a:chExt cx="707069" cy="664126"/>
              </a:xfrm>
            </p:grpSpPr>
            <p:sp>
              <p:nvSpPr>
                <p:cNvPr id="16" name="Rectangle 15">
                  <a:extLst>
                    <a:ext uri="{FF2B5EF4-FFF2-40B4-BE49-F238E27FC236}">
                      <a16:creationId xmlns:a16="http://schemas.microsoft.com/office/drawing/2014/main" id="{FF98BF51-E3F1-30AD-D535-CA2DCF1024A8}"/>
                    </a:ext>
                  </a:extLst>
                </p:cNvPr>
                <p:cNvSpPr/>
                <p:nvPr/>
              </p:nvSpPr>
              <p:spPr>
                <a:xfrm>
                  <a:off x="5148274" y="3357954"/>
                  <a:ext cx="78186" cy="79553"/>
                </a:xfrm>
                <a:prstGeom prst="rect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E" sz="1050" dirty="0"/>
                </a:p>
              </p:txBody>
            </p:sp>
            <p:sp>
              <p:nvSpPr>
                <p:cNvPr id="17" name="Rectangle 16">
                  <a:extLst>
                    <a:ext uri="{FF2B5EF4-FFF2-40B4-BE49-F238E27FC236}">
                      <a16:creationId xmlns:a16="http://schemas.microsoft.com/office/drawing/2014/main" id="{2F3E9486-C50F-25B7-A79A-9934CCEBB723}"/>
                    </a:ext>
                  </a:extLst>
                </p:cNvPr>
                <p:cNvSpPr/>
                <p:nvPr/>
              </p:nvSpPr>
              <p:spPr>
                <a:xfrm>
                  <a:off x="5148274" y="3680442"/>
                  <a:ext cx="78186" cy="79553"/>
                </a:xfrm>
                <a:prstGeom prst="rect">
                  <a:avLst/>
                </a:prstGeom>
                <a:solidFill>
                  <a:schemeClr val="accent1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E" sz="1050"/>
                </a:p>
              </p:txBody>
            </p:sp>
            <p:sp>
              <p:nvSpPr>
                <p:cNvPr id="18" name="Rectangle 17">
                  <a:extLst>
                    <a:ext uri="{FF2B5EF4-FFF2-40B4-BE49-F238E27FC236}">
                      <a16:creationId xmlns:a16="http://schemas.microsoft.com/office/drawing/2014/main" id="{925819EC-F628-E163-FDBE-B8FF3B79472A}"/>
                    </a:ext>
                  </a:extLst>
                </p:cNvPr>
                <p:cNvSpPr/>
                <p:nvPr/>
              </p:nvSpPr>
              <p:spPr>
                <a:xfrm>
                  <a:off x="5148274" y="3519198"/>
                  <a:ext cx="78186" cy="79553"/>
                </a:xfrm>
                <a:prstGeom prst="rect">
                  <a:avLst/>
                </a:prstGeom>
                <a:solidFill>
                  <a:srgbClr val="1882C6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E" sz="1050"/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74268C2D-CB42-661F-0A83-42EEF370D3BA}"/>
                    </a:ext>
                  </a:extLst>
                </p:cNvPr>
                <p:cNvSpPr txBox="1"/>
                <p:nvPr/>
              </p:nvSpPr>
              <p:spPr>
                <a:xfrm>
                  <a:off x="5259218" y="3275958"/>
                  <a:ext cx="596125" cy="1775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SE" sz="800" dirty="0"/>
                    <a:t>HOM.REF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7B618448-70C8-F867-6C30-9AEC8685D16D}"/>
                    </a:ext>
                  </a:extLst>
                </p:cNvPr>
                <p:cNvSpPr txBox="1"/>
                <p:nvPr/>
              </p:nvSpPr>
              <p:spPr>
                <a:xfrm>
                  <a:off x="5260253" y="3441669"/>
                  <a:ext cx="356493" cy="1775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SE" sz="800" dirty="0"/>
                    <a:t>HET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1373421A-913D-51D5-2AFC-D3EB1E3FBBCF}"/>
                    </a:ext>
                  </a:extLst>
                </p:cNvPr>
                <p:cNvSpPr txBox="1"/>
                <p:nvPr/>
              </p:nvSpPr>
              <p:spPr>
                <a:xfrm>
                  <a:off x="5259216" y="3602094"/>
                  <a:ext cx="596125" cy="1775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SE" sz="800" dirty="0"/>
                    <a:t>HOM.ALT</a:t>
                  </a:r>
                </a:p>
              </p:txBody>
            </p:sp>
            <p:sp>
              <p:nvSpPr>
                <p:cNvPr id="22" name="Rectangle 21">
                  <a:extLst>
                    <a:ext uri="{FF2B5EF4-FFF2-40B4-BE49-F238E27FC236}">
                      <a16:creationId xmlns:a16="http://schemas.microsoft.com/office/drawing/2014/main" id="{9667592E-412E-F625-1D0F-6B6AFB73C143}"/>
                    </a:ext>
                  </a:extLst>
                </p:cNvPr>
                <p:cNvSpPr/>
                <p:nvPr/>
              </p:nvSpPr>
              <p:spPr>
                <a:xfrm>
                  <a:off x="5148274" y="3842465"/>
                  <a:ext cx="78186" cy="79553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E" sz="1050"/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E01DFF92-60A1-C117-1085-D36885623E5E}"/>
                    </a:ext>
                  </a:extLst>
                </p:cNvPr>
                <p:cNvSpPr txBox="1"/>
                <p:nvPr/>
              </p:nvSpPr>
              <p:spPr>
                <a:xfrm>
                  <a:off x="5259216" y="3762520"/>
                  <a:ext cx="400809" cy="1775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SE" sz="800" dirty="0"/>
                    <a:t>MISS</a:t>
                  </a:r>
                </a:p>
              </p:txBody>
            </p:sp>
          </p:grpSp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E4156905-8813-EA8D-C3DA-22935B5D4259}"/>
                  </a:ext>
                </a:extLst>
              </p:cNvPr>
              <p:cNvGrpSpPr/>
              <p:nvPr/>
            </p:nvGrpSpPr>
            <p:grpSpPr>
              <a:xfrm>
                <a:off x="2321276" y="1915189"/>
                <a:ext cx="2895380" cy="599493"/>
                <a:chOff x="2945121" y="1386639"/>
                <a:chExt cx="2895380" cy="599493"/>
              </a:xfrm>
            </p:grpSpPr>
            <p:sp>
              <p:nvSpPr>
                <p:cNvPr id="13" name="Rectangle 12">
                  <a:extLst>
                    <a:ext uri="{FF2B5EF4-FFF2-40B4-BE49-F238E27FC236}">
                      <a16:creationId xmlns:a16="http://schemas.microsoft.com/office/drawing/2014/main" id="{F252CD6B-50E9-23CC-F63F-724C34308432}"/>
                    </a:ext>
                  </a:extLst>
                </p:cNvPr>
                <p:cNvSpPr/>
                <p:nvPr/>
              </p:nvSpPr>
              <p:spPr>
                <a:xfrm>
                  <a:off x="2945121" y="1600859"/>
                  <a:ext cx="78186" cy="79553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E" sz="1050"/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FED7EEDA-59E0-E339-6D07-9DF388AF4A1B}"/>
                    </a:ext>
                  </a:extLst>
                </p:cNvPr>
                <p:cNvSpPr txBox="1"/>
                <p:nvPr/>
              </p:nvSpPr>
              <p:spPr>
                <a:xfrm>
                  <a:off x="4550101" y="1386639"/>
                  <a:ext cx="1290400" cy="59949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SE" sz="800" dirty="0"/>
                    <a:t>Resolved APN </a:t>
                  </a:r>
                </a:p>
                <a:p>
                  <a:pPr algn="ctr"/>
                  <a:r>
                    <a:rPr lang="en-GB" sz="800" dirty="0"/>
                    <a:t>N</a:t>
                  </a:r>
                  <a:r>
                    <a:rPr lang="en-SE" sz="800" dirty="0"/>
                    <a:t>=25</a:t>
                  </a: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F099FE8E-7F27-CF8A-990C-DE8BC6A72118}"/>
                    </a:ext>
                  </a:extLst>
                </p:cNvPr>
                <p:cNvSpPr txBox="1"/>
                <p:nvPr/>
              </p:nvSpPr>
              <p:spPr>
                <a:xfrm>
                  <a:off x="2959565" y="1386639"/>
                  <a:ext cx="1269341" cy="5994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SE" sz="800" dirty="0"/>
                    <a:t>Renal scarring</a:t>
                  </a:r>
                </a:p>
                <a:p>
                  <a:pPr algn="ctr"/>
                  <a:r>
                    <a:rPr lang="en-GB" sz="800" dirty="0"/>
                    <a:t>N</a:t>
                  </a:r>
                  <a:r>
                    <a:rPr lang="en-SE" sz="800" dirty="0"/>
                    <a:t>=7</a:t>
                  </a:r>
                </a:p>
              </p:txBody>
            </p:sp>
          </p:grp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96BF8857-428D-6A11-40AF-5A0ED7892A67}"/>
                  </a:ext>
                </a:extLst>
              </p:cNvPr>
              <p:cNvSpPr txBox="1"/>
              <p:nvPr/>
            </p:nvSpPr>
            <p:spPr>
              <a:xfrm>
                <a:off x="2416421" y="1409707"/>
                <a:ext cx="4218908" cy="5167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E" sz="1200" dirty="0"/>
                  <a:t>Representative SNPs</a:t>
                </a:r>
              </a:p>
            </p:txBody>
          </p:sp>
        </p:grp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E39890C2-778D-DE42-A926-4D48CE5A60C9}"/>
                </a:ext>
              </a:extLst>
            </p:cNvPr>
            <p:cNvSpPr/>
            <p:nvPr/>
          </p:nvSpPr>
          <p:spPr>
            <a:xfrm>
              <a:off x="2282761" y="1369274"/>
              <a:ext cx="47729" cy="55352"/>
            </a:xfrm>
            <a:prstGeom prst="rect">
              <a:avLst/>
            </a:prstGeom>
            <a:solidFill>
              <a:srgbClr val="7030A0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E" sz="1050" dirty="0"/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FFD3FAC3-4E50-FB0F-BEC8-49791C9DE014}"/>
              </a:ext>
            </a:extLst>
          </p:cNvPr>
          <p:cNvSpPr txBox="1"/>
          <p:nvPr/>
        </p:nvSpPr>
        <p:spPr>
          <a:xfrm>
            <a:off x="116287" y="2142203"/>
            <a:ext cx="33831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rgbClr val="00437A"/>
                </a:solidFill>
              </a:rPr>
              <a:t>Nationwide prospective study of infant UTI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E6AE9361-3581-9581-2AC9-E3006EF5C392}"/>
              </a:ext>
            </a:extLst>
          </p:cNvPr>
          <p:cNvGrpSpPr/>
          <p:nvPr/>
        </p:nvGrpSpPr>
        <p:grpSpPr>
          <a:xfrm>
            <a:off x="463949" y="3472310"/>
            <a:ext cx="2363050" cy="1688493"/>
            <a:chOff x="580768" y="2923053"/>
            <a:chExt cx="6400835" cy="1580994"/>
          </a:xfrm>
        </p:grpSpPr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78783D19-3E11-6816-EDEE-4628E321ED63}"/>
                </a:ext>
              </a:extLst>
            </p:cNvPr>
            <p:cNvSpPr/>
            <p:nvPr/>
          </p:nvSpPr>
          <p:spPr>
            <a:xfrm>
              <a:off x="5246290" y="2936730"/>
              <a:ext cx="1735313" cy="622841"/>
            </a:xfrm>
            <a:prstGeom prst="rect">
              <a:avLst/>
            </a:prstGeom>
            <a:noFill/>
            <a:ln w="12700">
              <a:solidFill>
                <a:srgbClr val="296D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800" dirty="0">
                  <a:solidFill>
                    <a:srgbClr val="296DC0"/>
                  </a:solidFill>
                </a:rPr>
                <a:t>2</a:t>
              </a:r>
              <a:r>
                <a:rPr lang="en-GB" sz="800" baseline="30000" dirty="0">
                  <a:solidFill>
                    <a:srgbClr val="296DC0"/>
                  </a:solidFill>
                </a:rPr>
                <a:t>nd </a:t>
              </a:r>
              <a:r>
                <a:rPr lang="en-GB" sz="800" dirty="0">
                  <a:solidFill>
                    <a:srgbClr val="296DC0"/>
                  </a:solidFill>
                </a:rPr>
                <a:t>DMSA after </a:t>
              </a:r>
              <a:r>
                <a:rPr lang="en-GB" sz="800" u="sng" dirty="0">
                  <a:solidFill>
                    <a:srgbClr val="296DC0"/>
                  </a:solidFill>
                </a:rPr>
                <a:t>&gt; </a:t>
              </a:r>
              <a:r>
                <a:rPr lang="en-GB" sz="800" dirty="0">
                  <a:solidFill>
                    <a:srgbClr val="296DC0"/>
                  </a:solidFill>
                </a:rPr>
                <a:t>6 months</a:t>
              </a:r>
            </a:p>
            <a:p>
              <a:pPr algn="ctr"/>
              <a:r>
                <a:rPr lang="en-GB" sz="800" dirty="0">
                  <a:solidFill>
                    <a:srgbClr val="296DC0"/>
                  </a:solidFill>
                </a:rPr>
                <a:t> n= 129</a:t>
              </a: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5F69D19F-F771-90A6-8855-2B162D9AA966}"/>
                </a:ext>
              </a:extLst>
            </p:cNvPr>
            <p:cNvSpPr/>
            <p:nvPr/>
          </p:nvSpPr>
          <p:spPr>
            <a:xfrm>
              <a:off x="580768" y="2923053"/>
              <a:ext cx="1735313" cy="622841"/>
            </a:xfrm>
            <a:prstGeom prst="rect">
              <a:avLst/>
            </a:prstGeom>
            <a:solidFill>
              <a:srgbClr val="00385E"/>
            </a:solidFill>
            <a:ln w="41275">
              <a:solidFill>
                <a:srgbClr val="00385E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800" dirty="0"/>
                <a:t>Febrile UTI</a:t>
              </a:r>
            </a:p>
            <a:p>
              <a:pPr algn="ctr"/>
              <a:r>
                <a:rPr lang="en-GB" sz="800" dirty="0"/>
                <a:t>N=1087</a:t>
              </a: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C336370D-3DC8-1CAD-08D6-FB1A20699941}"/>
                </a:ext>
              </a:extLst>
            </p:cNvPr>
            <p:cNvSpPr/>
            <p:nvPr/>
          </p:nvSpPr>
          <p:spPr>
            <a:xfrm>
              <a:off x="2945492" y="2936730"/>
              <a:ext cx="1735313" cy="622841"/>
            </a:xfrm>
            <a:prstGeom prst="rect">
              <a:avLst/>
            </a:prstGeom>
            <a:noFill/>
            <a:ln w="12700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800" dirty="0">
                  <a:solidFill>
                    <a:srgbClr val="00437A"/>
                  </a:solidFill>
                </a:rPr>
                <a:t>1</a:t>
              </a:r>
              <a:r>
                <a:rPr lang="en-GB" sz="800" baseline="30000" dirty="0">
                  <a:solidFill>
                    <a:srgbClr val="00437A"/>
                  </a:solidFill>
                </a:rPr>
                <a:t>st </a:t>
              </a:r>
              <a:r>
                <a:rPr lang="en-GB" sz="800" dirty="0">
                  <a:solidFill>
                    <a:srgbClr val="00437A"/>
                  </a:solidFill>
                </a:rPr>
                <a:t>DMSA</a:t>
              </a:r>
            </a:p>
            <a:p>
              <a:pPr algn="ctr"/>
              <a:r>
                <a:rPr lang="en-GB" sz="800" dirty="0">
                  <a:solidFill>
                    <a:srgbClr val="00437A"/>
                  </a:solidFill>
                </a:rPr>
                <a:t>N=624 </a:t>
              </a:r>
            </a:p>
          </p:txBody>
        </p: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F1DBF934-82EF-8864-0905-60F25E205089}"/>
                </a:ext>
              </a:extLst>
            </p:cNvPr>
            <p:cNvCxnSpPr>
              <a:cxnSpLocks/>
              <a:endCxn id="37" idx="1"/>
            </p:cNvCxnSpPr>
            <p:nvPr/>
          </p:nvCxnSpPr>
          <p:spPr>
            <a:xfrm>
              <a:off x="4716701" y="3248150"/>
              <a:ext cx="529589" cy="1"/>
            </a:xfrm>
            <a:prstGeom prst="straightConnector1">
              <a:avLst/>
            </a:prstGeom>
            <a:ln w="9525">
              <a:solidFill>
                <a:srgbClr val="296DC0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A8D9EA8A-5C2A-5F46-2CFD-0388EB85625D}"/>
                </a:ext>
              </a:extLst>
            </p:cNvPr>
            <p:cNvSpPr/>
            <p:nvPr/>
          </p:nvSpPr>
          <p:spPr>
            <a:xfrm>
              <a:off x="2935061" y="3881206"/>
              <a:ext cx="1735313" cy="622841"/>
            </a:xfrm>
            <a:prstGeom prst="rect">
              <a:avLst/>
            </a:prstGeom>
            <a:noFill/>
            <a:ln w="12700">
              <a:solidFill>
                <a:srgbClr val="65AA0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800" dirty="0">
                  <a:solidFill>
                    <a:srgbClr val="65AA00"/>
                  </a:solidFill>
                </a:rPr>
                <a:t>1</a:t>
              </a:r>
              <a:r>
                <a:rPr lang="en-GB" sz="800" baseline="30000" dirty="0">
                  <a:solidFill>
                    <a:srgbClr val="65AA00"/>
                  </a:solidFill>
                </a:rPr>
                <a:t>st</a:t>
              </a:r>
              <a:r>
                <a:rPr lang="en-GB" sz="800" dirty="0">
                  <a:solidFill>
                    <a:srgbClr val="65AA00"/>
                  </a:solidFill>
                </a:rPr>
                <a:t> DMSA negative</a:t>
              </a:r>
            </a:p>
          </p:txBody>
        </p:sp>
        <p:cxnSp>
          <p:nvCxnSpPr>
            <p:cNvPr id="42" name="Straight Arrow Connector 41">
              <a:extLst>
                <a:ext uri="{FF2B5EF4-FFF2-40B4-BE49-F238E27FC236}">
                  <a16:creationId xmlns:a16="http://schemas.microsoft.com/office/drawing/2014/main" id="{69DAC388-9D00-35B2-313B-45F55B6EAFC6}"/>
                </a:ext>
              </a:extLst>
            </p:cNvPr>
            <p:cNvCxnSpPr>
              <a:cxnSpLocks/>
            </p:cNvCxnSpPr>
            <p:nvPr/>
          </p:nvCxnSpPr>
          <p:spPr>
            <a:xfrm>
              <a:off x="3789545" y="3600505"/>
              <a:ext cx="0" cy="222531"/>
            </a:xfrm>
            <a:prstGeom prst="straightConnector1">
              <a:avLst/>
            </a:prstGeom>
            <a:ln w="9525">
              <a:solidFill>
                <a:srgbClr val="65AA00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2893C3E6-0A00-6D5B-34C3-AC968D3636E9}"/>
              </a:ext>
            </a:extLst>
          </p:cNvPr>
          <p:cNvSpPr txBox="1"/>
          <p:nvPr/>
        </p:nvSpPr>
        <p:spPr>
          <a:xfrm>
            <a:off x="4350837" y="1783335"/>
            <a:ext cx="37913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rgbClr val="00437A"/>
                </a:solidFill>
              </a:rPr>
              <a:t>DNA association analysis segregates the genetic profile of renal scarring </a:t>
            </a: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CC09EA36-B19A-6A59-DA4E-F8421FEE6281}"/>
              </a:ext>
            </a:extLst>
          </p:cNvPr>
          <p:cNvGrpSpPr/>
          <p:nvPr/>
        </p:nvGrpSpPr>
        <p:grpSpPr>
          <a:xfrm>
            <a:off x="2625530" y="2708578"/>
            <a:ext cx="1660846" cy="2405966"/>
            <a:chOff x="4628249" y="2225535"/>
            <a:chExt cx="2306421" cy="3080246"/>
          </a:xfrm>
        </p:grpSpPr>
        <p:sp>
          <p:nvSpPr>
            <p:cNvPr id="45" name="Freeform: Shape 46">
              <a:extLst>
                <a:ext uri="{FF2B5EF4-FFF2-40B4-BE49-F238E27FC236}">
                  <a16:creationId xmlns:a16="http://schemas.microsoft.com/office/drawing/2014/main" id="{502E3F6E-3D80-6D9A-8041-726AB155539E}"/>
                </a:ext>
              </a:extLst>
            </p:cNvPr>
            <p:cNvSpPr/>
            <p:nvPr/>
          </p:nvSpPr>
          <p:spPr>
            <a:xfrm>
              <a:off x="5831411" y="3188972"/>
              <a:ext cx="279880" cy="449850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sz="1200" dirty="0"/>
            </a:p>
          </p:txBody>
        </p:sp>
        <p:sp>
          <p:nvSpPr>
            <p:cNvPr id="46" name="Freeform: Shape 46">
              <a:extLst>
                <a:ext uri="{FF2B5EF4-FFF2-40B4-BE49-F238E27FC236}">
                  <a16:creationId xmlns:a16="http://schemas.microsoft.com/office/drawing/2014/main" id="{0DF90CD0-9DAA-56E4-2B3E-7A30889C8922}"/>
                </a:ext>
              </a:extLst>
            </p:cNvPr>
            <p:cNvSpPr/>
            <p:nvPr/>
          </p:nvSpPr>
          <p:spPr>
            <a:xfrm>
              <a:off x="5841864" y="3952102"/>
              <a:ext cx="295157" cy="426927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sz="1200" dirty="0"/>
            </a:p>
          </p:txBody>
        </p: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D48A8032-E200-637B-C859-507F22D814BE}"/>
                </a:ext>
              </a:extLst>
            </p:cNvPr>
            <p:cNvGrpSpPr/>
            <p:nvPr/>
          </p:nvGrpSpPr>
          <p:grpSpPr>
            <a:xfrm>
              <a:off x="4628249" y="2225535"/>
              <a:ext cx="2306421" cy="3080246"/>
              <a:chOff x="4628249" y="2225535"/>
              <a:chExt cx="2306421" cy="3080246"/>
            </a:xfrm>
          </p:grpSpPr>
          <p:grpSp>
            <p:nvGrpSpPr>
              <p:cNvPr id="48" name="Group 47">
                <a:extLst>
                  <a:ext uri="{FF2B5EF4-FFF2-40B4-BE49-F238E27FC236}">
                    <a16:creationId xmlns:a16="http://schemas.microsoft.com/office/drawing/2014/main" id="{B8FABF76-CBA0-84AE-6472-0DD254AAE6F4}"/>
                  </a:ext>
                </a:extLst>
              </p:cNvPr>
              <p:cNvGrpSpPr/>
              <p:nvPr/>
            </p:nvGrpSpPr>
            <p:grpSpPr>
              <a:xfrm>
                <a:off x="4628249" y="2225535"/>
                <a:ext cx="2306421" cy="3080246"/>
                <a:chOff x="5964200" y="2114759"/>
                <a:chExt cx="2306421" cy="3080246"/>
              </a:xfrm>
            </p:grpSpPr>
            <p:sp>
              <p:nvSpPr>
                <p:cNvPr id="51" name="Freeform: Shape 46">
                  <a:extLst>
                    <a:ext uri="{FF2B5EF4-FFF2-40B4-BE49-F238E27FC236}">
                      <a16:creationId xmlns:a16="http://schemas.microsoft.com/office/drawing/2014/main" id="{50A07282-592F-C3A2-E881-AEF11F8D7900}"/>
                    </a:ext>
                  </a:extLst>
                </p:cNvPr>
                <p:cNvSpPr/>
                <p:nvPr/>
              </p:nvSpPr>
              <p:spPr>
                <a:xfrm>
                  <a:off x="7025415" y="3688926"/>
                  <a:ext cx="295157" cy="426927"/>
                </a:xfrm>
                <a:custGeom>
                  <a:avLst/>
                  <a:gdLst>
                    <a:gd name="connsiteX0" fmla="*/ 427832 w 855663"/>
                    <a:gd name="connsiteY0" fmla="*/ 350043 h 1750218"/>
                    <a:gd name="connsiteX1" fmla="*/ 556181 w 855663"/>
                    <a:gd name="connsiteY1" fmla="*/ 365601 h 1750218"/>
                    <a:gd name="connsiteX2" fmla="*/ 719535 w 855663"/>
                    <a:gd name="connsiteY2" fmla="*/ 451168 h 1750218"/>
                    <a:gd name="connsiteX3" fmla="*/ 742872 w 855663"/>
                    <a:gd name="connsiteY3" fmla="*/ 493950 h 1750218"/>
                    <a:gd name="connsiteX4" fmla="*/ 851774 w 855663"/>
                    <a:gd name="connsiteY4" fmla="*/ 956786 h 1750218"/>
                    <a:gd name="connsiteX5" fmla="*/ 855663 w 855663"/>
                    <a:gd name="connsiteY5" fmla="*/ 976232 h 1750218"/>
                    <a:gd name="connsiteX6" fmla="*/ 777876 w 855663"/>
                    <a:gd name="connsiteY6" fmla="*/ 1054020 h 1750218"/>
                    <a:gd name="connsiteX7" fmla="*/ 703977 w 855663"/>
                    <a:gd name="connsiteY7" fmla="*/ 995680 h 1750218"/>
                    <a:gd name="connsiteX8" fmla="*/ 622301 w 855663"/>
                    <a:gd name="connsiteY8" fmla="*/ 657304 h 1750218"/>
                    <a:gd name="connsiteX9" fmla="*/ 622301 w 855663"/>
                    <a:gd name="connsiteY9" fmla="*/ 1750218 h 1750218"/>
                    <a:gd name="connsiteX10" fmla="*/ 466726 w 855663"/>
                    <a:gd name="connsiteY10" fmla="*/ 1750218 h 1750218"/>
                    <a:gd name="connsiteX11" fmla="*/ 466726 w 855663"/>
                    <a:gd name="connsiteY11" fmla="*/ 1050131 h 1750218"/>
                    <a:gd name="connsiteX12" fmla="*/ 388938 w 855663"/>
                    <a:gd name="connsiteY12" fmla="*/ 1050131 h 1750218"/>
                    <a:gd name="connsiteX13" fmla="*/ 388938 w 855663"/>
                    <a:gd name="connsiteY13" fmla="*/ 1750218 h 1750218"/>
                    <a:gd name="connsiteX14" fmla="*/ 233363 w 855663"/>
                    <a:gd name="connsiteY14" fmla="*/ 1750218 h 1750218"/>
                    <a:gd name="connsiteX15" fmla="*/ 233363 w 855663"/>
                    <a:gd name="connsiteY15" fmla="*/ 661193 h 1750218"/>
                    <a:gd name="connsiteX16" fmla="*/ 151686 w 855663"/>
                    <a:gd name="connsiteY16" fmla="*/ 999569 h 1750218"/>
                    <a:gd name="connsiteX17" fmla="*/ 77788 w 855663"/>
                    <a:gd name="connsiteY17" fmla="*/ 1057910 h 1750218"/>
                    <a:gd name="connsiteX18" fmla="*/ 0 w 855663"/>
                    <a:gd name="connsiteY18" fmla="*/ 980123 h 1750218"/>
                    <a:gd name="connsiteX19" fmla="*/ 3889 w 855663"/>
                    <a:gd name="connsiteY19" fmla="*/ 960675 h 1750218"/>
                    <a:gd name="connsiteX20" fmla="*/ 112792 w 855663"/>
                    <a:gd name="connsiteY20" fmla="*/ 497840 h 1750218"/>
                    <a:gd name="connsiteX21" fmla="*/ 136129 w 855663"/>
                    <a:gd name="connsiteY21" fmla="*/ 455057 h 1750218"/>
                    <a:gd name="connsiteX22" fmla="*/ 299482 w 855663"/>
                    <a:gd name="connsiteY22" fmla="*/ 369490 h 1750218"/>
                    <a:gd name="connsiteX23" fmla="*/ 427832 w 855663"/>
                    <a:gd name="connsiteY23" fmla="*/ 350043 h 1750218"/>
                    <a:gd name="connsiteX24" fmla="*/ 427831 w 855663"/>
                    <a:gd name="connsiteY24" fmla="*/ 0 h 1750218"/>
                    <a:gd name="connsiteX25" fmla="*/ 583406 w 855663"/>
                    <a:gd name="connsiteY25" fmla="*/ 155575 h 1750218"/>
                    <a:gd name="connsiteX26" fmla="*/ 427831 w 855663"/>
                    <a:gd name="connsiteY26" fmla="*/ 311150 h 1750218"/>
                    <a:gd name="connsiteX27" fmla="*/ 272256 w 855663"/>
                    <a:gd name="connsiteY27" fmla="*/ 155575 h 1750218"/>
                    <a:gd name="connsiteX28" fmla="*/ 427831 w 855663"/>
                    <a:gd name="connsiteY28" fmla="*/ 0 h 17502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</a:cxnLst>
                  <a:rect l="l" t="t" r="r" b="b"/>
                  <a:pathLst>
                    <a:path w="855663" h="1750218">
                      <a:moveTo>
                        <a:pt x="427832" y="350043"/>
                      </a:moveTo>
                      <a:cubicBezTo>
                        <a:pt x="470615" y="350043"/>
                        <a:pt x="513398" y="357821"/>
                        <a:pt x="556181" y="365601"/>
                      </a:cubicBezTo>
                      <a:cubicBezTo>
                        <a:pt x="618412" y="385047"/>
                        <a:pt x="672862" y="412273"/>
                        <a:pt x="719535" y="451168"/>
                      </a:cubicBezTo>
                      <a:cubicBezTo>
                        <a:pt x="731203" y="462835"/>
                        <a:pt x="738983" y="478392"/>
                        <a:pt x="742872" y="493950"/>
                      </a:cubicBezTo>
                      <a:lnTo>
                        <a:pt x="851774" y="956786"/>
                      </a:lnTo>
                      <a:cubicBezTo>
                        <a:pt x="851774" y="960675"/>
                        <a:pt x="855663" y="968454"/>
                        <a:pt x="855663" y="976232"/>
                      </a:cubicBezTo>
                      <a:cubicBezTo>
                        <a:pt x="855663" y="1019016"/>
                        <a:pt x="820659" y="1054020"/>
                        <a:pt x="777876" y="1054020"/>
                      </a:cubicBezTo>
                      <a:cubicBezTo>
                        <a:pt x="742872" y="1054020"/>
                        <a:pt x="711757" y="1026795"/>
                        <a:pt x="703977" y="995680"/>
                      </a:cubicBezTo>
                      <a:lnTo>
                        <a:pt x="622301" y="657304"/>
                      </a:lnTo>
                      <a:lnTo>
                        <a:pt x="622301" y="1750218"/>
                      </a:lnTo>
                      <a:lnTo>
                        <a:pt x="466726" y="1750218"/>
                      </a:lnTo>
                      <a:lnTo>
                        <a:pt x="466726" y="1050131"/>
                      </a:lnTo>
                      <a:lnTo>
                        <a:pt x="388938" y="1050131"/>
                      </a:lnTo>
                      <a:lnTo>
                        <a:pt x="388938" y="1750218"/>
                      </a:lnTo>
                      <a:lnTo>
                        <a:pt x="233363" y="1750218"/>
                      </a:lnTo>
                      <a:lnTo>
                        <a:pt x="233363" y="661193"/>
                      </a:lnTo>
                      <a:lnTo>
                        <a:pt x="151686" y="999569"/>
                      </a:lnTo>
                      <a:cubicBezTo>
                        <a:pt x="143907" y="1030684"/>
                        <a:pt x="112792" y="1057910"/>
                        <a:pt x="77788" y="1057910"/>
                      </a:cubicBezTo>
                      <a:cubicBezTo>
                        <a:pt x="35004" y="1057910"/>
                        <a:pt x="0" y="1022905"/>
                        <a:pt x="0" y="980123"/>
                      </a:cubicBezTo>
                      <a:cubicBezTo>
                        <a:pt x="0" y="972343"/>
                        <a:pt x="3889" y="964564"/>
                        <a:pt x="3889" y="960675"/>
                      </a:cubicBezTo>
                      <a:lnTo>
                        <a:pt x="112792" y="497840"/>
                      </a:lnTo>
                      <a:cubicBezTo>
                        <a:pt x="116682" y="482281"/>
                        <a:pt x="124460" y="466725"/>
                        <a:pt x="136129" y="455057"/>
                      </a:cubicBezTo>
                      <a:cubicBezTo>
                        <a:pt x="182801" y="416162"/>
                        <a:pt x="237252" y="385047"/>
                        <a:pt x="299482" y="369490"/>
                      </a:cubicBezTo>
                      <a:cubicBezTo>
                        <a:pt x="342265" y="357821"/>
                        <a:pt x="385049" y="350043"/>
                        <a:pt x="427832" y="350043"/>
                      </a:cubicBezTo>
                      <a:close/>
                      <a:moveTo>
                        <a:pt x="427831" y="0"/>
                      </a:moveTo>
                      <a:cubicBezTo>
                        <a:pt x="513753" y="0"/>
                        <a:pt x="583406" y="69653"/>
                        <a:pt x="583406" y="155575"/>
                      </a:cubicBezTo>
                      <a:cubicBezTo>
                        <a:pt x="583406" y="241496"/>
                        <a:pt x="513753" y="311150"/>
                        <a:pt x="427831" y="311150"/>
                      </a:cubicBezTo>
                      <a:cubicBezTo>
                        <a:pt x="341910" y="311150"/>
                        <a:pt x="272256" y="241496"/>
                        <a:pt x="272256" y="155575"/>
                      </a:cubicBezTo>
                      <a:cubicBezTo>
                        <a:pt x="272256" y="69653"/>
                        <a:pt x="341910" y="0"/>
                        <a:pt x="427831" y="0"/>
                      </a:cubicBezTo>
                      <a:close/>
                    </a:path>
                  </a:pathLst>
                </a:custGeom>
                <a:solidFill>
                  <a:srgbClr val="00437A"/>
                </a:solidFill>
                <a:ln w="15081" cap="flat">
                  <a:noFill/>
                  <a:prstDash val="solid"/>
                  <a:miter/>
                </a:ln>
              </p:spPr>
              <p:txBody>
                <a:bodyPr wrap="square" rtlCol="0" anchor="ctr">
                  <a:noAutofit/>
                </a:bodyPr>
                <a:lstStyle/>
                <a:p>
                  <a:endParaRPr lang="en-US" sz="1200" dirty="0"/>
                </a:p>
              </p:txBody>
            </p:sp>
            <p:sp>
              <p:nvSpPr>
                <p:cNvPr id="52" name="Freeform: Shape 46">
                  <a:extLst>
                    <a:ext uri="{FF2B5EF4-FFF2-40B4-BE49-F238E27FC236}">
                      <a16:creationId xmlns:a16="http://schemas.microsoft.com/office/drawing/2014/main" id="{156D79C1-083A-885B-A339-BA85D91C5844}"/>
                    </a:ext>
                  </a:extLst>
                </p:cNvPr>
                <p:cNvSpPr/>
                <p:nvPr/>
              </p:nvSpPr>
              <p:spPr>
                <a:xfrm>
                  <a:off x="7014962" y="2925796"/>
                  <a:ext cx="279880" cy="449850"/>
                </a:xfrm>
                <a:custGeom>
                  <a:avLst/>
                  <a:gdLst>
                    <a:gd name="connsiteX0" fmla="*/ 427832 w 855663"/>
                    <a:gd name="connsiteY0" fmla="*/ 350043 h 1750218"/>
                    <a:gd name="connsiteX1" fmla="*/ 556181 w 855663"/>
                    <a:gd name="connsiteY1" fmla="*/ 365601 h 1750218"/>
                    <a:gd name="connsiteX2" fmla="*/ 719535 w 855663"/>
                    <a:gd name="connsiteY2" fmla="*/ 451168 h 1750218"/>
                    <a:gd name="connsiteX3" fmla="*/ 742872 w 855663"/>
                    <a:gd name="connsiteY3" fmla="*/ 493950 h 1750218"/>
                    <a:gd name="connsiteX4" fmla="*/ 851774 w 855663"/>
                    <a:gd name="connsiteY4" fmla="*/ 956786 h 1750218"/>
                    <a:gd name="connsiteX5" fmla="*/ 855663 w 855663"/>
                    <a:gd name="connsiteY5" fmla="*/ 976232 h 1750218"/>
                    <a:gd name="connsiteX6" fmla="*/ 777876 w 855663"/>
                    <a:gd name="connsiteY6" fmla="*/ 1054020 h 1750218"/>
                    <a:gd name="connsiteX7" fmla="*/ 703977 w 855663"/>
                    <a:gd name="connsiteY7" fmla="*/ 995680 h 1750218"/>
                    <a:gd name="connsiteX8" fmla="*/ 622301 w 855663"/>
                    <a:gd name="connsiteY8" fmla="*/ 657304 h 1750218"/>
                    <a:gd name="connsiteX9" fmla="*/ 622301 w 855663"/>
                    <a:gd name="connsiteY9" fmla="*/ 1750218 h 1750218"/>
                    <a:gd name="connsiteX10" fmla="*/ 466726 w 855663"/>
                    <a:gd name="connsiteY10" fmla="*/ 1750218 h 1750218"/>
                    <a:gd name="connsiteX11" fmla="*/ 466726 w 855663"/>
                    <a:gd name="connsiteY11" fmla="*/ 1050131 h 1750218"/>
                    <a:gd name="connsiteX12" fmla="*/ 388938 w 855663"/>
                    <a:gd name="connsiteY12" fmla="*/ 1050131 h 1750218"/>
                    <a:gd name="connsiteX13" fmla="*/ 388938 w 855663"/>
                    <a:gd name="connsiteY13" fmla="*/ 1750218 h 1750218"/>
                    <a:gd name="connsiteX14" fmla="*/ 233363 w 855663"/>
                    <a:gd name="connsiteY14" fmla="*/ 1750218 h 1750218"/>
                    <a:gd name="connsiteX15" fmla="*/ 233363 w 855663"/>
                    <a:gd name="connsiteY15" fmla="*/ 661193 h 1750218"/>
                    <a:gd name="connsiteX16" fmla="*/ 151686 w 855663"/>
                    <a:gd name="connsiteY16" fmla="*/ 999569 h 1750218"/>
                    <a:gd name="connsiteX17" fmla="*/ 77788 w 855663"/>
                    <a:gd name="connsiteY17" fmla="*/ 1057910 h 1750218"/>
                    <a:gd name="connsiteX18" fmla="*/ 0 w 855663"/>
                    <a:gd name="connsiteY18" fmla="*/ 980123 h 1750218"/>
                    <a:gd name="connsiteX19" fmla="*/ 3889 w 855663"/>
                    <a:gd name="connsiteY19" fmla="*/ 960675 h 1750218"/>
                    <a:gd name="connsiteX20" fmla="*/ 112792 w 855663"/>
                    <a:gd name="connsiteY20" fmla="*/ 497840 h 1750218"/>
                    <a:gd name="connsiteX21" fmla="*/ 136129 w 855663"/>
                    <a:gd name="connsiteY21" fmla="*/ 455057 h 1750218"/>
                    <a:gd name="connsiteX22" fmla="*/ 299482 w 855663"/>
                    <a:gd name="connsiteY22" fmla="*/ 369490 h 1750218"/>
                    <a:gd name="connsiteX23" fmla="*/ 427832 w 855663"/>
                    <a:gd name="connsiteY23" fmla="*/ 350043 h 1750218"/>
                    <a:gd name="connsiteX24" fmla="*/ 427831 w 855663"/>
                    <a:gd name="connsiteY24" fmla="*/ 0 h 1750218"/>
                    <a:gd name="connsiteX25" fmla="*/ 583406 w 855663"/>
                    <a:gd name="connsiteY25" fmla="*/ 155575 h 1750218"/>
                    <a:gd name="connsiteX26" fmla="*/ 427831 w 855663"/>
                    <a:gd name="connsiteY26" fmla="*/ 311150 h 1750218"/>
                    <a:gd name="connsiteX27" fmla="*/ 272256 w 855663"/>
                    <a:gd name="connsiteY27" fmla="*/ 155575 h 1750218"/>
                    <a:gd name="connsiteX28" fmla="*/ 427831 w 855663"/>
                    <a:gd name="connsiteY28" fmla="*/ 0 h 17502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</a:cxnLst>
                  <a:rect l="l" t="t" r="r" b="b"/>
                  <a:pathLst>
                    <a:path w="855663" h="1750218">
                      <a:moveTo>
                        <a:pt x="427832" y="350043"/>
                      </a:moveTo>
                      <a:cubicBezTo>
                        <a:pt x="470615" y="350043"/>
                        <a:pt x="513398" y="357821"/>
                        <a:pt x="556181" y="365601"/>
                      </a:cubicBezTo>
                      <a:cubicBezTo>
                        <a:pt x="618412" y="385047"/>
                        <a:pt x="672862" y="412273"/>
                        <a:pt x="719535" y="451168"/>
                      </a:cubicBezTo>
                      <a:cubicBezTo>
                        <a:pt x="731203" y="462835"/>
                        <a:pt x="738983" y="478392"/>
                        <a:pt x="742872" y="493950"/>
                      </a:cubicBezTo>
                      <a:lnTo>
                        <a:pt x="851774" y="956786"/>
                      </a:lnTo>
                      <a:cubicBezTo>
                        <a:pt x="851774" y="960675"/>
                        <a:pt x="855663" y="968454"/>
                        <a:pt x="855663" y="976232"/>
                      </a:cubicBezTo>
                      <a:cubicBezTo>
                        <a:pt x="855663" y="1019016"/>
                        <a:pt x="820659" y="1054020"/>
                        <a:pt x="777876" y="1054020"/>
                      </a:cubicBezTo>
                      <a:cubicBezTo>
                        <a:pt x="742872" y="1054020"/>
                        <a:pt x="711757" y="1026795"/>
                        <a:pt x="703977" y="995680"/>
                      </a:cubicBezTo>
                      <a:lnTo>
                        <a:pt x="622301" y="657304"/>
                      </a:lnTo>
                      <a:lnTo>
                        <a:pt x="622301" y="1750218"/>
                      </a:lnTo>
                      <a:lnTo>
                        <a:pt x="466726" y="1750218"/>
                      </a:lnTo>
                      <a:lnTo>
                        <a:pt x="466726" y="1050131"/>
                      </a:lnTo>
                      <a:lnTo>
                        <a:pt x="388938" y="1050131"/>
                      </a:lnTo>
                      <a:lnTo>
                        <a:pt x="388938" y="1750218"/>
                      </a:lnTo>
                      <a:lnTo>
                        <a:pt x="233363" y="1750218"/>
                      </a:lnTo>
                      <a:lnTo>
                        <a:pt x="233363" y="661193"/>
                      </a:lnTo>
                      <a:lnTo>
                        <a:pt x="151686" y="999569"/>
                      </a:lnTo>
                      <a:cubicBezTo>
                        <a:pt x="143907" y="1030684"/>
                        <a:pt x="112792" y="1057910"/>
                        <a:pt x="77788" y="1057910"/>
                      </a:cubicBezTo>
                      <a:cubicBezTo>
                        <a:pt x="35004" y="1057910"/>
                        <a:pt x="0" y="1022905"/>
                        <a:pt x="0" y="980123"/>
                      </a:cubicBezTo>
                      <a:cubicBezTo>
                        <a:pt x="0" y="972343"/>
                        <a:pt x="3889" y="964564"/>
                        <a:pt x="3889" y="960675"/>
                      </a:cubicBezTo>
                      <a:lnTo>
                        <a:pt x="112792" y="497840"/>
                      </a:lnTo>
                      <a:cubicBezTo>
                        <a:pt x="116682" y="482281"/>
                        <a:pt x="124460" y="466725"/>
                        <a:pt x="136129" y="455057"/>
                      </a:cubicBezTo>
                      <a:cubicBezTo>
                        <a:pt x="182801" y="416162"/>
                        <a:pt x="237252" y="385047"/>
                        <a:pt x="299482" y="369490"/>
                      </a:cubicBezTo>
                      <a:cubicBezTo>
                        <a:pt x="342265" y="357821"/>
                        <a:pt x="385049" y="350043"/>
                        <a:pt x="427832" y="350043"/>
                      </a:cubicBezTo>
                      <a:close/>
                      <a:moveTo>
                        <a:pt x="427831" y="0"/>
                      </a:moveTo>
                      <a:cubicBezTo>
                        <a:pt x="513753" y="0"/>
                        <a:pt x="583406" y="69653"/>
                        <a:pt x="583406" y="155575"/>
                      </a:cubicBezTo>
                      <a:cubicBezTo>
                        <a:pt x="583406" y="241496"/>
                        <a:pt x="513753" y="311150"/>
                        <a:pt x="427831" y="311150"/>
                      </a:cubicBezTo>
                      <a:cubicBezTo>
                        <a:pt x="341910" y="311150"/>
                        <a:pt x="272256" y="241496"/>
                        <a:pt x="272256" y="155575"/>
                      </a:cubicBezTo>
                      <a:cubicBezTo>
                        <a:pt x="272256" y="69653"/>
                        <a:pt x="341910" y="0"/>
                        <a:pt x="427831" y="0"/>
                      </a:cubicBezTo>
                      <a:close/>
                    </a:path>
                  </a:pathLst>
                </a:custGeom>
                <a:solidFill>
                  <a:srgbClr val="AA0065"/>
                </a:solidFill>
                <a:ln w="15081" cap="flat">
                  <a:noFill/>
                  <a:prstDash val="solid"/>
                  <a:miter/>
                </a:ln>
              </p:spPr>
              <p:txBody>
                <a:bodyPr wrap="square" rtlCol="0" anchor="ctr">
                  <a:noAutofit/>
                </a:bodyPr>
                <a:lstStyle/>
                <a:p>
                  <a:endParaRPr lang="en-US" sz="1200" dirty="0"/>
                </a:p>
              </p:txBody>
            </p: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71F0E0DA-D5E8-F4EA-5ECE-F00F51D80463}"/>
                    </a:ext>
                  </a:extLst>
                </p:cNvPr>
                <p:cNvSpPr txBox="1"/>
                <p:nvPr/>
              </p:nvSpPr>
              <p:spPr>
                <a:xfrm>
                  <a:off x="6236197" y="2114759"/>
                  <a:ext cx="1762425" cy="59104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dirty="0">
                      <a:solidFill>
                        <a:srgbClr val="AA0065"/>
                      </a:solidFill>
                    </a:rPr>
                    <a:t>Renal scarring</a:t>
                  </a:r>
                </a:p>
                <a:p>
                  <a:pPr algn="ctr"/>
                  <a:r>
                    <a:rPr lang="en-GB" sz="1200" dirty="0">
                      <a:solidFill>
                        <a:srgbClr val="AA0065"/>
                      </a:solidFill>
                    </a:rPr>
                    <a:t>N=63 </a:t>
                  </a:r>
                </a:p>
              </p:txBody>
            </p: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C3B4BDA9-E232-5EEE-73C7-471F337C7ABB}"/>
                    </a:ext>
                  </a:extLst>
                </p:cNvPr>
                <p:cNvSpPr txBox="1"/>
                <p:nvPr/>
              </p:nvSpPr>
              <p:spPr>
                <a:xfrm>
                  <a:off x="5964200" y="4367537"/>
                  <a:ext cx="2306421" cy="82746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dirty="0">
                      <a:solidFill>
                        <a:srgbClr val="00437A"/>
                      </a:solidFill>
                    </a:rPr>
                    <a:t>Resolved kidney involvement</a:t>
                  </a:r>
                </a:p>
                <a:p>
                  <a:pPr algn="ctr"/>
                  <a:r>
                    <a:rPr lang="en-GB" sz="1200" dirty="0">
                      <a:solidFill>
                        <a:srgbClr val="00437A"/>
                      </a:solidFill>
                    </a:rPr>
                    <a:t>N=66</a:t>
                  </a:r>
                </a:p>
              </p:txBody>
            </p:sp>
            <p:cxnSp>
              <p:nvCxnSpPr>
                <p:cNvPr id="55" name="Straight Arrow Connector 54">
                  <a:extLst>
                    <a:ext uri="{FF2B5EF4-FFF2-40B4-BE49-F238E27FC236}">
                      <a16:creationId xmlns:a16="http://schemas.microsoft.com/office/drawing/2014/main" id="{116C9D66-18B7-DEE2-C3A7-96496145D4C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6347809" y="3176313"/>
                  <a:ext cx="514411" cy="286428"/>
                </a:xfrm>
                <a:prstGeom prst="straightConnector1">
                  <a:avLst/>
                </a:prstGeom>
                <a:ln w="9525">
                  <a:solidFill>
                    <a:srgbClr val="AA0065"/>
                  </a:solidFill>
                  <a:headEnd w="lg" len="med"/>
                  <a:tailEnd type="arrow" w="lg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Straight Arrow Connector 55">
                  <a:extLst>
                    <a:ext uri="{FF2B5EF4-FFF2-40B4-BE49-F238E27FC236}">
                      <a16:creationId xmlns:a16="http://schemas.microsoft.com/office/drawing/2014/main" id="{2555E840-F4D6-8227-01BB-6DE7632658C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340049" y="3488438"/>
                  <a:ext cx="509965" cy="323478"/>
                </a:xfrm>
                <a:prstGeom prst="straightConnector1">
                  <a:avLst/>
                </a:prstGeom>
                <a:ln w="9525">
                  <a:solidFill>
                    <a:srgbClr val="00437A"/>
                  </a:solidFill>
                  <a:headEnd w="lg" len="med"/>
                  <a:tailEnd type="arrow" w="lg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9" name="Freeform: Shape 46">
                <a:extLst>
                  <a:ext uri="{FF2B5EF4-FFF2-40B4-BE49-F238E27FC236}">
                    <a16:creationId xmlns:a16="http://schemas.microsoft.com/office/drawing/2014/main" id="{1F96FC68-23A5-5514-0CD2-13DC5E5443B1}"/>
                  </a:ext>
                </a:extLst>
              </p:cNvPr>
              <p:cNvSpPr/>
              <p:nvPr/>
            </p:nvSpPr>
            <p:spPr>
              <a:xfrm>
                <a:off x="5983811" y="3341372"/>
                <a:ext cx="279880" cy="449850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AA0065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 sz="1200" dirty="0"/>
              </a:p>
            </p:txBody>
          </p:sp>
          <p:sp>
            <p:nvSpPr>
              <p:cNvPr id="50" name="Freeform: Shape 46">
                <a:extLst>
                  <a:ext uri="{FF2B5EF4-FFF2-40B4-BE49-F238E27FC236}">
                    <a16:creationId xmlns:a16="http://schemas.microsoft.com/office/drawing/2014/main" id="{BCC76DD9-B53F-5892-99D7-2CBCB2892C1A}"/>
                  </a:ext>
                </a:extLst>
              </p:cNvPr>
              <p:cNvSpPr/>
              <p:nvPr/>
            </p:nvSpPr>
            <p:spPr>
              <a:xfrm>
                <a:off x="5994264" y="4104502"/>
                <a:ext cx="295157" cy="426927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00437A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 sz="1200" dirty="0"/>
              </a:p>
            </p:txBody>
          </p:sp>
        </p:grpSp>
      </p:grp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B7D3671D-A625-D31B-61B0-E4C65B36DD91}"/>
              </a:ext>
            </a:extLst>
          </p:cNvPr>
          <p:cNvCxnSpPr>
            <a:cxnSpLocks/>
            <a:endCxn id="39" idx="1"/>
          </p:cNvCxnSpPr>
          <p:nvPr/>
        </p:nvCxnSpPr>
        <p:spPr>
          <a:xfrm flipV="1">
            <a:off x="1159396" y="3819513"/>
            <a:ext cx="177558" cy="1927"/>
          </a:xfrm>
          <a:prstGeom prst="straightConnector1">
            <a:avLst/>
          </a:prstGeom>
          <a:ln w="9525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8" name="Table 57">
            <a:extLst>
              <a:ext uri="{FF2B5EF4-FFF2-40B4-BE49-F238E27FC236}">
                <a16:creationId xmlns:a16="http://schemas.microsoft.com/office/drawing/2014/main" id="{B8DC0B4E-0D0E-8A7D-21D0-E7F97E65BA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352041"/>
              </p:ext>
            </p:extLst>
          </p:nvPr>
        </p:nvGraphicFramePr>
        <p:xfrm>
          <a:off x="9431829" y="2571119"/>
          <a:ext cx="2061482" cy="2761743"/>
        </p:xfrm>
        <a:graphic>
          <a:graphicData uri="http://schemas.openxmlformats.org/drawingml/2006/table">
            <a:tbl>
              <a:tblPr firstRow="1" firstCol="1" bandRow="1">
                <a:tableStyleId>{69012ECD-51FC-41F1-AA8D-1B2483CD663E}</a:tableStyleId>
              </a:tblPr>
              <a:tblGrid>
                <a:gridCol w="446682">
                  <a:extLst>
                    <a:ext uri="{9D8B030D-6E8A-4147-A177-3AD203B41FA5}">
                      <a16:colId xmlns:a16="http://schemas.microsoft.com/office/drawing/2014/main" val="3263728785"/>
                    </a:ext>
                  </a:extLst>
                </a:gridCol>
                <a:gridCol w="421668">
                  <a:extLst>
                    <a:ext uri="{9D8B030D-6E8A-4147-A177-3AD203B41FA5}">
                      <a16:colId xmlns:a16="http://schemas.microsoft.com/office/drawing/2014/main" val="511756810"/>
                    </a:ext>
                  </a:extLst>
                </a:gridCol>
                <a:gridCol w="473466">
                  <a:extLst>
                    <a:ext uri="{9D8B030D-6E8A-4147-A177-3AD203B41FA5}">
                      <a16:colId xmlns:a16="http://schemas.microsoft.com/office/drawing/2014/main" val="1301993235"/>
                    </a:ext>
                  </a:extLst>
                </a:gridCol>
                <a:gridCol w="719666">
                  <a:extLst>
                    <a:ext uri="{9D8B030D-6E8A-4147-A177-3AD203B41FA5}">
                      <a16:colId xmlns:a16="http://schemas.microsoft.com/office/drawing/2014/main" val="2955222828"/>
                    </a:ext>
                  </a:extLst>
                </a:gridCol>
              </a:tblGrid>
              <a:tr h="248207">
                <a:tc>
                  <a:txBody>
                    <a:bodyPr/>
                    <a:lstStyle/>
                    <a:p>
                      <a:pPr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Symbol</a:t>
                      </a:r>
                      <a:endParaRPr lang="en-SE" sz="4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>
                    <a:solidFill>
                      <a:schemeClr val="accent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Non XY or PAR</a:t>
                      </a:r>
                      <a:endParaRPr lang="en-SE" sz="4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>
                    <a:solidFill>
                      <a:schemeClr val="accent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Odds ratio</a:t>
                      </a:r>
                      <a:endParaRPr lang="en-SE" sz="4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>
                    <a:solidFill>
                      <a:schemeClr val="accent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P Value</a:t>
                      </a:r>
                      <a:endParaRPr lang="en-SE" sz="4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>
                    <a:solidFill>
                      <a:schemeClr val="accent1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0845275"/>
                  </a:ext>
                </a:extLst>
              </a:tr>
              <a:tr h="150747">
                <a:tc>
                  <a:txBody>
                    <a:bodyPr/>
                    <a:lstStyle/>
                    <a:p>
                      <a:pPr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GALNT18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Yes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28.2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1,23268E-05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extLst>
                  <a:ext uri="{0D108BD9-81ED-4DB2-BD59-A6C34878D82A}">
                    <a16:rowId xmlns:a16="http://schemas.microsoft.com/office/drawing/2014/main" val="1058536958"/>
                  </a:ext>
                </a:extLst>
              </a:tr>
              <a:tr h="150747">
                <a:tc>
                  <a:txBody>
                    <a:bodyPr/>
                    <a:lstStyle/>
                    <a:p>
                      <a:pPr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MT-TP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Yes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Inf</a:t>
                      </a:r>
                      <a:endParaRPr lang="en-SE" sz="4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1,50306E-05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extLst>
                  <a:ext uri="{0D108BD9-81ED-4DB2-BD59-A6C34878D82A}">
                    <a16:rowId xmlns:a16="http://schemas.microsoft.com/office/drawing/2014/main" val="99069535"/>
                  </a:ext>
                </a:extLst>
              </a:tr>
              <a:tr h="150747">
                <a:tc>
                  <a:txBody>
                    <a:bodyPr/>
                    <a:lstStyle/>
                    <a:p>
                      <a:pPr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MT-TL-2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Yes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Inf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1,50306E-05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extLst>
                  <a:ext uri="{0D108BD9-81ED-4DB2-BD59-A6C34878D82A}">
                    <a16:rowId xmlns:a16="http://schemas.microsoft.com/office/drawing/2014/main" val="892346657"/>
                  </a:ext>
                </a:extLst>
              </a:tr>
              <a:tr h="150747">
                <a:tc>
                  <a:txBody>
                    <a:bodyPr/>
                    <a:lstStyle/>
                    <a:p>
                      <a:pPr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MT-TK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Yes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Inf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1,50306E-05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extLst>
                  <a:ext uri="{0D108BD9-81ED-4DB2-BD59-A6C34878D82A}">
                    <a16:rowId xmlns:a16="http://schemas.microsoft.com/office/drawing/2014/main" val="312023434"/>
                  </a:ext>
                </a:extLst>
              </a:tr>
              <a:tr h="150747">
                <a:tc>
                  <a:txBody>
                    <a:bodyPr/>
                    <a:lstStyle/>
                    <a:p>
                      <a:pPr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MT-TH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Yes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Inf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1,50306E-05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extLst>
                  <a:ext uri="{0D108BD9-81ED-4DB2-BD59-A6C34878D82A}">
                    <a16:rowId xmlns:a16="http://schemas.microsoft.com/office/drawing/2014/main" val="1090367215"/>
                  </a:ext>
                </a:extLst>
              </a:tr>
              <a:tr h="150747">
                <a:tc>
                  <a:txBody>
                    <a:bodyPr/>
                    <a:lstStyle/>
                    <a:p>
                      <a:pPr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MT-TG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Yes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inf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1,50306E-05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extLst>
                  <a:ext uri="{0D108BD9-81ED-4DB2-BD59-A6C34878D82A}">
                    <a16:rowId xmlns:a16="http://schemas.microsoft.com/office/drawing/2014/main" val="1888415164"/>
                  </a:ext>
                </a:extLst>
              </a:tr>
              <a:tr h="150747">
                <a:tc>
                  <a:txBody>
                    <a:bodyPr/>
                    <a:lstStyle/>
                    <a:p>
                      <a:pPr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MT-TE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Yes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Inf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1,50306E-05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extLst>
                  <a:ext uri="{0D108BD9-81ED-4DB2-BD59-A6C34878D82A}">
                    <a16:rowId xmlns:a16="http://schemas.microsoft.com/office/drawing/2014/main" val="1808766374"/>
                  </a:ext>
                </a:extLst>
              </a:tr>
              <a:tr h="150747">
                <a:tc>
                  <a:txBody>
                    <a:bodyPr/>
                    <a:lstStyle/>
                    <a:p>
                      <a:pPr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MT-TD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Yes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Inf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1,50306E-05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extLst>
                  <a:ext uri="{0D108BD9-81ED-4DB2-BD59-A6C34878D82A}">
                    <a16:rowId xmlns:a16="http://schemas.microsoft.com/office/drawing/2014/main" val="367570750"/>
                  </a:ext>
                </a:extLst>
              </a:tr>
              <a:tr h="179943">
                <a:tc>
                  <a:txBody>
                    <a:bodyPr/>
                    <a:lstStyle/>
                    <a:p>
                      <a:pPr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MT-ND6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Yes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Inf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1,50306E-05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extLst>
                  <a:ext uri="{0D108BD9-81ED-4DB2-BD59-A6C34878D82A}">
                    <a16:rowId xmlns:a16="http://schemas.microsoft.com/office/drawing/2014/main" val="3817309693"/>
                  </a:ext>
                </a:extLst>
              </a:tr>
              <a:tr h="150747">
                <a:tc>
                  <a:txBody>
                    <a:bodyPr/>
                    <a:lstStyle/>
                    <a:p>
                      <a:pPr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MT-ND5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Yes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Inf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1,50306E-05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extLst>
                  <a:ext uri="{0D108BD9-81ED-4DB2-BD59-A6C34878D82A}">
                    <a16:rowId xmlns:a16="http://schemas.microsoft.com/office/drawing/2014/main" val="956252631"/>
                  </a:ext>
                </a:extLst>
              </a:tr>
              <a:tr h="150747">
                <a:tc>
                  <a:txBody>
                    <a:bodyPr/>
                    <a:lstStyle/>
                    <a:p>
                      <a:pPr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MT-ND4L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Yes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Inf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1,50306E-05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extLst>
                  <a:ext uri="{0D108BD9-81ED-4DB2-BD59-A6C34878D82A}">
                    <a16:rowId xmlns:a16="http://schemas.microsoft.com/office/drawing/2014/main" val="1171558275"/>
                  </a:ext>
                </a:extLst>
              </a:tr>
              <a:tr h="150747">
                <a:tc>
                  <a:txBody>
                    <a:bodyPr/>
                    <a:lstStyle/>
                    <a:p>
                      <a:pPr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MT-ND3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Yes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Inf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1,50306E-05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extLst>
                  <a:ext uri="{0D108BD9-81ED-4DB2-BD59-A6C34878D82A}">
                    <a16:rowId xmlns:a16="http://schemas.microsoft.com/office/drawing/2014/main" val="1306020301"/>
                  </a:ext>
                </a:extLst>
              </a:tr>
              <a:tr h="150747">
                <a:tc>
                  <a:txBody>
                    <a:bodyPr/>
                    <a:lstStyle/>
                    <a:p>
                      <a:pPr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MT-CYB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Yes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Inf</a:t>
                      </a:r>
                      <a:endParaRPr lang="en-SE" sz="4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1,50306E-05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extLst>
                  <a:ext uri="{0D108BD9-81ED-4DB2-BD59-A6C34878D82A}">
                    <a16:rowId xmlns:a16="http://schemas.microsoft.com/office/drawing/2014/main" val="1342769017"/>
                  </a:ext>
                </a:extLst>
              </a:tr>
              <a:tr h="150747">
                <a:tc>
                  <a:txBody>
                    <a:bodyPr/>
                    <a:lstStyle/>
                    <a:p>
                      <a:pPr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MT-CO3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Yes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Inf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1,50306E-05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extLst>
                  <a:ext uri="{0D108BD9-81ED-4DB2-BD59-A6C34878D82A}">
                    <a16:rowId xmlns:a16="http://schemas.microsoft.com/office/drawing/2014/main" val="2714903187"/>
                  </a:ext>
                </a:extLst>
              </a:tr>
              <a:tr h="150747">
                <a:tc>
                  <a:txBody>
                    <a:bodyPr/>
                    <a:lstStyle/>
                    <a:p>
                      <a:pPr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MT-CO2</a:t>
                      </a:r>
                      <a:endParaRPr lang="en-SE" sz="4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Yes</a:t>
                      </a:r>
                      <a:endParaRPr lang="en-SE" sz="4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Inf</a:t>
                      </a:r>
                      <a:endParaRPr lang="en-SE" sz="4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</a:rPr>
                        <a:t>1,50306E-05</a:t>
                      </a:r>
                      <a:endParaRPr lang="en-SE" sz="4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 Unicode MS" panose="020B0604020202020204" pitchFamily="34" charset="-128"/>
                      </a:endParaRPr>
                    </a:p>
                  </a:txBody>
                  <a:tcPr marL="29164" marR="29164" marT="29164" marB="29164"/>
                </a:tc>
                <a:extLst>
                  <a:ext uri="{0D108BD9-81ED-4DB2-BD59-A6C34878D82A}">
                    <a16:rowId xmlns:a16="http://schemas.microsoft.com/office/drawing/2014/main" val="1325973691"/>
                  </a:ext>
                </a:extLst>
              </a:tr>
            </a:tbl>
          </a:graphicData>
        </a:graphic>
      </p:graphicFrame>
      <p:sp>
        <p:nvSpPr>
          <p:cNvPr id="59" name="TextBox 58">
            <a:extLst>
              <a:ext uri="{FF2B5EF4-FFF2-40B4-BE49-F238E27FC236}">
                <a16:creationId xmlns:a16="http://schemas.microsoft.com/office/drawing/2014/main" id="{A37AB169-8751-A14A-696F-1EB7A8112602}"/>
              </a:ext>
            </a:extLst>
          </p:cNvPr>
          <p:cNvSpPr txBox="1"/>
          <p:nvPr/>
        </p:nvSpPr>
        <p:spPr>
          <a:xfrm>
            <a:off x="8361721" y="1805117"/>
            <a:ext cx="37913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rgbClr val="00437A"/>
                </a:solidFill>
              </a:rPr>
              <a:t>Polymorphic genes associated with renal scarring 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85</TotalTime>
  <Words>220</Words>
  <Application>Microsoft Office PowerPoint</Application>
  <PresentationFormat>Widescreen</PresentationFormat>
  <Paragraphs>9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6</cp:revision>
  <dcterms:created xsi:type="dcterms:W3CDTF">2019-06-13T12:30:18Z</dcterms:created>
  <dcterms:modified xsi:type="dcterms:W3CDTF">2024-05-15T19:15:57Z</dcterms:modified>
</cp:coreProperties>
</file>